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7" roundtripDataSignature="AMtx7mhuGhX9IaMsp7vrpcNNj9gD4q8cV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010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470988" y="9002918"/>
            <a:ext cx="59160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de-DE" sz="1200" b="1" i="0" u="none" strike="noStrike" cap="none" dirty="0" err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</a:t>
            </a:r>
            <a:r>
              <a:rPr lang="de-DE" sz="1200" b="1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S4</a:t>
            </a:r>
            <a:r>
              <a:rPr lang="de-DE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reatio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>
                <a:solidFill>
                  <a:schemeClr val="dk1"/>
                </a:solidFill>
              </a:rPr>
              <a:t>down-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amples. (A</a:t>
            </a:r>
            <a:r>
              <a:rPr lang="de-DE" sz="1200" dirty="0">
                <a:solidFill>
                  <a:schemeClr val="dk1"/>
                </a:solidFill>
              </a:rPr>
              <a:t>)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Read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unt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ll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taset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(B</a:t>
            </a:r>
            <a:r>
              <a:rPr lang="de-DE" sz="1200" dirty="0">
                <a:solidFill>
                  <a:schemeClr val="dk1"/>
                </a:solidFill>
              </a:rPr>
              <a:t>)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mpositio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ructur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ll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taset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(C</a:t>
            </a:r>
            <a:r>
              <a:rPr lang="de-DE" sz="1200" dirty="0">
                <a:solidFill>
                  <a:schemeClr val="dk1"/>
                </a:solidFill>
              </a:rPr>
              <a:t>)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mpositio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ructur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ample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elected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or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bsampling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0341" y="364868"/>
            <a:ext cx="2877318" cy="863805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A4-Papier (210 x 297 mm)</PresentationFormat>
  <Paragraphs>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ay Dr. Grégoire</dc:creator>
  <cp:lastModifiedBy>Denay Dr. Grégoire</cp:lastModifiedBy>
  <cp:revision>2</cp:revision>
  <dcterms:created xsi:type="dcterms:W3CDTF">2022-08-22T10:51:50Z</dcterms:created>
  <dcterms:modified xsi:type="dcterms:W3CDTF">2023-02-22T08:22:01Z</dcterms:modified>
</cp:coreProperties>
</file>